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90006-EE1D-4C7D-ACAC-0A17CD800D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0AF85-3C7B-438B-BAB1-882D13D479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362E9-3758-4D21-B253-9E73D9A90C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DDA72-47E6-4C74-9ECE-8A36D5D851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C0616-88AA-49D5-AF2F-F70BB5D6C8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4940F-3985-4FC5-8B68-1FECAED4E6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E3161-E642-4C4C-A7D0-DA474E9BD4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07027-0BB2-4BE7-B069-9E101F4EA6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D9126-4989-4676-9F65-6BEA171A1E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E0527-0721-4D1D-A70F-7F58C4B80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DC522-A389-49C5-8FD5-676FBFD59B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19F50-9156-4FC9-8999-C040A39DE0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8A7669-8B7D-4CDB-8F35-EA22C11A742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609480" y="457200"/>
            <a:ext cx="5683320" cy="46483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1"/>
          <p:cNvSpPr/>
          <p:nvPr/>
        </p:nvSpPr>
        <p:spPr>
          <a:xfrm>
            <a:off x="914400" y="5410080"/>
            <a:ext cx="518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figure shows the secondary structure of SbSLSP. The helix, strands and coils are represented by pink rods, arrow and solid lines, respectivel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avinashstud1</dc:creator>
  <dc:description/>
  <dc:language>en-US</dc:language>
  <cp:lastModifiedBy>user</cp:lastModifiedBy>
  <dcterms:modified xsi:type="dcterms:W3CDTF">2016-05-25T21:25:00Z</dcterms:modified>
  <cp:revision>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Out To">
    <vt:lpwstr/>
  </property>
  <property fmtid="{D5CDD505-2E9C-101B-9397-08002B2CF9AE}" pid="3" name="DocumentId">
    <vt:lpwstr>Presentation 3.ppt</vt:lpwstr>
  </property>
  <property fmtid="{D5CDD505-2E9C-101B-9397-08002B2CF9AE}" pid="4" name="DocumentType">
    <vt:lpwstr>Presentation</vt:lpwstr>
  </property>
  <property fmtid="{D5CDD505-2E9C-101B-9397-08002B2CF9AE}" pid="5" name="FileFormat">
    <vt:lpwstr>PPT</vt:lpwstr>
  </property>
  <property fmtid="{D5CDD505-2E9C-101B-9397-08002B2CF9AE}" pid="6" name="IsDeleted">
    <vt:lpwstr>0</vt:lpwstr>
  </property>
  <property fmtid="{D5CDD505-2E9C-101B-9397-08002B2CF9AE}" pid="7" name="StageName">
    <vt:lpwstr>Author's Proof</vt:lpwstr>
  </property>
  <property fmtid="{D5CDD505-2E9C-101B-9397-08002B2CF9AE}" pid="8" name="TitleName">
    <vt:lpwstr>Presentation 3.ppt</vt:lpwstr>
  </property>
</Properties>
</file>